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4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679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62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17EBD81-DDCF-4394-9D53-15499AAC64DC}" type="datetimeFigureOut">
              <a:rPr lang="en-GB" smtClean="0"/>
              <a:t>05/02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04EFCC3-C08D-42E9-AE17-D801792739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3360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CD5166-24B3-4E19-B995-E052CAF2FD4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0A9420C-74C9-49BB-AD41-28EE86C5870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BC8B18-351C-48E0-9472-A630922949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05/02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E053A5-2EE6-4B5B-8C68-7AEFBAB58C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5936FA-2ECA-4E12-972C-072926AACB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58365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2DB603-F780-4278-B99F-10B213E58F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1824337-225E-4619-AD80-82B24D9805B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CBD175-7A87-4606-B941-02F2CC391D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05/02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C3B324-66A8-4E27-AB83-83D80A7147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3F7DD6-8B32-49D5-8C6C-67425064CF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03310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8758E29-E635-4399-9CD9-46327BC7CB5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36CAEA6-0304-4E7E-8DD9-4E7B3FDE73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822AF5-7E5B-41E4-BB84-26BB63BB62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05/02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7E407D-22C3-4181-9B8D-6F57882640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F47847-837C-4827-8211-DE386ABD20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40945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F984A5-DD37-4F65-A5C6-00D4914754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9A43F39-45A7-4064-9419-38FA43480AF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BCFF4C-3DBE-4D7D-9D82-2B7311D9B2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05/02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296C82-54D2-4335-B75E-98F7FD02AE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0A9AE4-4915-4B70-ADF9-8803E011B6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64574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1FF222-E43C-497F-A8A0-86E98E72D6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5078A5E-6C7F-4F2A-BC05-AF16FFE720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9085B8-86A9-4E5F-BBFC-BBD99D9D0A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05/02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B3B987-0B15-4835-9466-D378DC5DCF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C07BE3-A330-4B3F-B8C8-221544BB30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56821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AC8D33-B9CE-4060-86FF-D1E63DF072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42BDDC4-9E2C-470E-8614-FEF2C0C06F9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13CA981-C392-4CD8-874B-E445CA860D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F4B2A15-259B-4351-97D8-AED26DAA9D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05/02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A4A461E-7716-4F2C-A590-7E9C5F5BC1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360FD94-D0BF-4462-839C-302621E15F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00076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C4A57A-19A1-4077-8939-730B5FFA5B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92A289-EDA8-44A2-BDF5-D7CF7A6889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992B2CC-1EE1-4F01-B2D8-3F59075915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E5D7109-7E5E-4123-A877-9B5072C05AD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279AE05-E585-4FEB-9FE4-5780487C8C3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FF49309-17B0-433A-86BE-A146548FAD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05/02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9FD9909-C228-4A80-8EE4-4220326047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67FB830-4967-4887-832C-6DE14DA726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05699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978A0D-C8D7-41CD-9131-0FBA2A421C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5EA9B54-893B-4E50-94CD-8053CD06B5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05/02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95BE61D-B329-4B2D-8E6C-4CBF322A26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AA6BEC3-86B4-447C-A9EA-F11ADA3D85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95888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314AE8A-D537-443B-97FE-D0A73B4506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05/02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0F0BA55-1FEE-4324-9EA5-0596C0B5DC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36D1075-0534-4C35-AA88-2767F45360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26442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58152F-F243-4D26-9E4A-DA17E8B265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5B3255A-4C51-4196-A55C-F8E6119A96C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D006397-CE0B-4D42-9B8A-296B2A0EA0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456B42B-99D5-45EE-8825-3C877B0339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05/02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71BCDF0-27C7-4BEF-BF33-BBB1F02D45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F0076C0-854F-47BF-8811-28B3A66756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51288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5E49C9-BFAD-446C-809A-6BA92E4238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636115C-F9B9-4CF2-BD07-B2ED49320CE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AC80B9A-0C94-4FDB-BD83-29C4D85B25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9D287A7-4E67-4825-8549-2CE233B7B7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05/02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39D5B43-1D10-44D7-9329-2D734A5E57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8DBA00B-0818-4388-9EC9-000329D2FD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10592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FCD8008-BD23-4FF3-B2C8-AEB1BFA1B9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6C2C572-2629-4EB6-8B9C-6F580C9A4F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729891-84FF-4E29-8D3C-97CDFD2F137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6E97E2-6761-46FF-B48E-E80B97A8F655}" type="datetimeFigureOut">
              <a:rPr lang="en-GB" smtClean="0"/>
              <a:t>05/02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F1E135-001E-4D84-A68E-E24216B85A3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25D331-C372-4209-83CA-16098BF2E6B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48439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DF7A37ED-1A9C-77D8-77BE-CD8CEE9258D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81060646"/>
              </p:ext>
            </p:extLst>
          </p:nvPr>
        </p:nvGraphicFramePr>
        <p:xfrm>
          <a:off x="119047" y="637289"/>
          <a:ext cx="7092260" cy="196787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181518">
                  <a:extLst>
                    <a:ext uri="{9D8B030D-6E8A-4147-A177-3AD203B41FA5}">
                      <a16:colId xmlns:a16="http://schemas.microsoft.com/office/drawing/2014/main" val="3505064390"/>
                    </a:ext>
                  </a:extLst>
                </a:gridCol>
                <a:gridCol w="1181518">
                  <a:extLst>
                    <a:ext uri="{9D8B030D-6E8A-4147-A177-3AD203B41FA5}">
                      <a16:colId xmlns:a16="http://schemas.microsoft.com/office/drawing/2014/main" val="3192034345"/>
                    </a:ext>
                  </a:extLst>
                </a:gridCol>
                <a:gridCol w="1182306">
                  <a:extLst>
                    <a:ext uri="{9D8B030D-6E8A-4147-A177-3AD203B41FA5}">
                      <a16:colId xmlns:a16="http://schemas.microsoft.com/office/drawing/2014/main" val="1868440926"/>
                    </a:ext>
                  </a:extLst>
                </a:gridCol>
                <a:gridCol w="1182306">
                  <a:extLst>
                    <a:ext uri="{9D8B030D-6E8A-4147-A177-3AD203B41FA5}">
                      <a16:colId xmlns:a16="http://schemas.microsoft.com/office/drawing/2014/main" val="588814093"/>
                    </a:ext>
                  </a:extLst>
                </a:gridCol>
                <a:gridCol w="1182306">
                  <a:extLst>
                    <a:ext uri="{9D8B030D-6E8A-4147-A177-3AD203B41FA5}">
                      <a16:colId xmlns:a16="http://schemas.microsoft.com/office/drawing/2014/main" val="1082515046"/>
                    </a:ext>
                  </a:extLst>
                </a:gridCol>
                <a:gridCol w="1182306">
                  <a:extLst>
                    <a:ext uri="{9D8B030D-6E8A-4147-A177-3AD203B41FA5}">
                      <a16:colId xmlns:a16="http://schemas.microsoft.com/office/drawing/2014/main" val="861794331"/>
                    </a:ext>
                  </a:extLst>
                </a:gridCol>
              </a:tblGrid>
              <a:tr h="105307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 dirty="0">
                          <a:effectLst/>
                        </a:rPr>
                        <a:t>Module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 dirty="0">
                          <a:effectLst/>
                        </a:rPr>
                        <a:t>Gene number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 dirty="0">
                          <a:effectLst/>
                        </a:rPr>
                        <a:t>iPSC-IS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 dirty="0">
                          <a:effectLst/>
                        </a:rPr>
                        <a:t>HLC-IS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 dirty="0">
                          <a:effectLst/>
                        </a:rPr>
                        <a:t>Oncogenes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 dirty="0" err="1">
                          <a:effectLst/>
                        </a:rPr>
                        <a:t>Tsupp</a:t>
                      </a:r>
                      <a:r>
                        <a:rPr lang="en-GB" sz="1200" dirty="0">
                          <a:effectLst/>
                        </a:rPr>
                        <a:t> genes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134831360"/>
                  </a:ext>
                </a:extLst>
              </a:tr>
              <a:tr h="175086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Brown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1,650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53.76%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67.52%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1.52%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2.61%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93258976"/>
                  </a:ext>
                </a:extLst>
              </a:tr>
              <a:tr h="175086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 dirty="0">
                          <a:effectLst/>
                        </a:rPr>
                        <a:t>Turquoise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8,694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41.87%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55.18%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1.06%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1.23%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749219766"/>
                  </a:ext>
                </a:extLst>
              </a:tr>
              <a:tr h="175086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Black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150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26.67%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38.67%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2.00%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 dirty="0">
                          <a:effectLst/>
                        </a:rPr>
                        <a:t>0.67%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994035575"/>
                  </a:ext>
                </a:extLst>
              </a:tr>
              <a:tr h="175086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Blue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2,023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31.49%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45.67%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0.40%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0.84%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885810424"/>
                  </a:ext>
                </a:extLst>
              </a:tr>
              <a:tr h="175086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Green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461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34.49%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55.53%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0.87%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2.60%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753948100"/>
                  </a:ext>
                </a:extLst>
              </a:tr>
              <a:tr h="175086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Red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291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25.77%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47.42%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1.03%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0.34%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286760373"/>
                  </a:ext>
                </a:extLst>
              </a:tr>
              <a:tr h="175086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Magenta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17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0.00%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0.00%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0.00%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0.00%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075000720"/>
                  </a:ext>
                </a:extLst>
              </a:tr>
              <a:tr h="175086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Pink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36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0.03%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 dirty="0">
                          <a:effectLst/>
                        </a:rPr>
                        <a:t>0.00%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0.00%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0.00%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194877425"/>
                  </a:ext>
                </a:extLst>
              </a:tr>
              <a:tr h="175086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 dirty="0">
                          <a:effectLst/>
                        </a:rPr>
                        <a:t>Yellow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653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0.16%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0.26%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>
                          <a:effectLst/>
                        </a:rPr>
                        <a:t>0.31%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200" dirty="0">
                          <a:effectLst/>
                        </a:rPr>
                        <a:t>0.00%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965651880"/>
                  </a:ext>
                </a:extLst>
              </a:tr>
            </a:tbl>
          </a:graphicData>
        </a:graphic>
      </p:graphicFrame>
      <p:sp>
        <p:nvSpPr>
          <p:cNvPr id="5" name="Rectangle 1">
            <a:extLst>
              <a:ext uri="{FF2B5EF4-FFF2-40B4-BE49-F238E27FC236}">
                <a16:creationId xmlns:a16="http://schemas.microsoft.com/office/drawing/2014/main" id="{10189EFD-9027-4302-691C-EC3B1F161AE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66147" y="3129712"/>
            <a:ext cx="9474835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7DFE16E-AAF3-77B2-4E9F-EA7D6B583325}"/>
              </a:ext>
            </a:extLst>
          </p:cNvPr>
          <p:cNvSpPr txBox="1"/>
          <p:nvPr/>
        </p:nvSpPr>
        <p:spPr>
          <a:xfrm>
            <a:off x="27912" y="2683844"/>
            <a:ext cx="7274529" cy="9178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14000"/>
              </a:lnSpc>
            </a:pPr>
            <a:r>
              <a:rPr lang="en-GB" sz="12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GB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summary of modules identified by WGCNA, differentiated by colours. Each module represents the total number of genes within the module, the percentage associated with </a:t>
            </a:r>
            <a:r>
              <a:rPr lang="en-GB" sz="1200" dirty="0" err="1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HR</a:t>
            </a:r>
            <a:r>
              <a:rPr lang="en-GB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GB" sz="1200" dirty="0" err="1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HV</a:t>
            </a:r>
            <a:r>
              <a:rPr lang="en-GB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insertion sites in iPSCs or HLCs, and their categorisation as oncogenes or tumour suppressor genes. Notably, brown, turquoise, and green modules </a:t>
            </a:r>
            <a:r>
              <a:rPr lang="en-GB" sz="12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were</a:t>
            </a:r>
            <a:r>
              <a:rPr lang="en-GB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more strongly associated with </a:t>
            </a:r>
            <a:r>
              <a:rPr lang="en-GB" sz="1200" dirty="0" err="1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HR</a:t>
            </a:r>
            <a:r>
              <a:rPr lang="en-GB" sz="12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GB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infected iPSCs or HLCs with a marked proportion of tumour suppressor genes.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765F417-CB88-A05F-A580-E6D42DE085DC}"/>
              </a:ext>
            </a:extLst>
          </p:cNvPr>
          <p:cNvSpPr txBox="1"/>
          <p:nvPr/>
        </p:nvSpPr>
        <p:spPr>
          <a:xfrm>
            <a:off x="-1" y="220531"/>
            <a:ext cx="1057598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able S3. Co-expression modules reveal key gene subsets with diverse functional implications across infected iPSCs and HLCs.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9267743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683</TotalTime>
  <Words>193</Words>
  <Application>Microsoft Office PowerPoint</Application>
  <PresentationFormat>Widescreen</PresentationFormat>
  <Paragraphs>6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qlain Suleman (Staff)</dc:creator>
  <cp:lastModifiedBy>Suleman, Saqlain</cp:lastModifiedBy>
  <cp:revision>30</cp:revision>
  <dcterms:created xsi:type="dcterms:W3CDTF">2024-01-05T10:52:35Z</dcterms:created>
  <dcterms:modified xsi:type="dcterms:W3CDTF">2025-02-05T15:45:06Z</dcterms:modified>
</cp:coreProperties>
</file>